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7" d="100"/>
          <a:sy n="117" d="100"/>
        </p:scale>
        <p:origin x="1940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12528-56A3-42D4-BBF4-6530E9EA0C3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38263" y="1143000"/>
            <a:ext cx="4181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44D115-42CE-4362-BCEB-61F261E0FD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035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44D115-42CE-4362-BCEB-61F261E0FDB8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330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2234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482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5216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9419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815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1306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15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3304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2332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2031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76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9A24F-AD77-4D9C-90D0-4A260CCF43C8}" type="datetimeFigureOut">
              <a:rPr lang="zh-CN" altLang="en-US" smtClean="0"/>
              <a:t>2024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2692A-137D-4A6B-A776-21F3A6FF4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2660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7AA93708-7E36-0CFF-059F-84C2BA841A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9542" y="634558"/>
            <a:ext cx="5873832" cy="236905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AF47110-2958-559C-7A46-AFC7A44631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8911" y="3287530"/>
            <a:ext cx="5798164" cy="421633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8767DE3-5E13-41BA-3B99-C857A3616832}"/>
              </a:ext>
            </a:extLst>
          </p:cNvPr>
          <p:cNvSpPr txBox="1"/>
          <p:nvPr/>
        </p:nvSpPr>
        <p:spPr>
          <a:xfrm>
            <a:off x="8330293" y="211439"/>
            <a:ext cx="13852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i="1" dirty="0" err="1">
                <a:latin typeface="Times New Roman" panose="02020603050405020304" pitchFamily="18" charset="0"/>
                <a:ea typeface="宋体" panose="02010600030101010101" pitchFamily="2" charset="-122"/>
              </a:rPr>
              <a:t>psbK-psbl</a:t>
            </a:r>
            <a:endParaRPr lang="zh-CN" altLang="en-US" i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F5002DB-F0A5-986D-5A7A-0C38C683028A}"/>
              </a:ext>
            </a:extLst>
          </p:cNvPr>
          <p:cNvSpPr txBox="1"/>
          <p:nvPr/>
        </p:nvSpPr>
        <p:spPr>
          <a:xfrm>
            <a:off x="2339070" y="265226"/>
            <a:ext cx="16097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i="1" dirty="0" err="1">
                <a:latin typeface="Times New Roman" panose="02020603050405020304" pitchFamily="18" charset="0"/>
                <a:ea typeface="宋体" panose="02010600030101010101" pitchFamily="2" charset="-122"/>
              </a:rPr>
              <a:t>atpF-atpH</a:t>
            </a:r>
            <a:endParaRPr lang="zh-CN" altLang="en-US" i="1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471FA8C-FA1E-A070-5CD6-8B51FFBEAAB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26401"/>
          <a:stretch/>
        </p:blipFill>
        <p:spPr>
          <a:xfrm>
            <a:off x="238711" y="580772"/>
            <a:ext cx="5965531" cy="248899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51C970A-7142-1B56-9921-9FE1E222D65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2776" y="3287530"/>
            <a:ext cx="5785118" cy="395147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A679A9A-0ECE-779A-2224-E89EF5491E1B}"/>
              </a:ext>
            </a:extLst>
          </p:cNvPr>
          <p:cNvSpPr txBox="1"/>
          <p:nvPr/>
        </p:nvSpPr>
        <p:spPr>
          <a:xfrm>
            <a:off x="1469571" y="7930928"/>
            <a:ext cx="933994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Barcoding identification of plant material duckweed</a:t>
            </a:r>
          </a:p>
        </p:txBody>
      </p:sp>
    </p:spTree>
    <p:extLst>
      <p:ext uri="{BB962C8B-B14F-4D97-AF65-F5344CB8AC3E}">
        <p14:creationId xmlns:p14="http://schemas.microsoft.com/office/powerpoint/2010/main" val="26524625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25B2BE1-8952-1385-4B18-2381CB7949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6924"/>
            <a:ext cx="12192000" cy="764494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402ECC0B-0F18-065D-CC6C-7AA5DD567D4E}"/>
              </a:ext>
            </a:extLst>
          </p:cNvPr>
          <p:cNvSpPr txBox="1"/>
          <p:nvPr/>
        </p:nvSpPr>
        <p:spPr>
          <a:xfrm>
            <a:off x="2237013" y="7560814"/>
            <a:ext cx="859427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zh-CN" altLang="en-US" dirty="0"/>
              <a:t> 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 S2. Construction of gene co-expression network</a:t>
            </a:r>
          </a:p>
        </p:txBody>
      </p:sp>
    </p:spTree>
    <p:extLst>
      <p:ext uri="{BB962C8B-B14F-4D97-AF65-F5344CB8AC3E}">
        <p14:creationId xmlns:p14="http://schemas.microsoft.com/office/powerpoint/2010/main" val="3709407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4</TotalTime>
  <Words>25</Words>
  <Application>Microsoft Office PowerPoint</Application>
  <PresentationFormat>自定义</PresentationFormat>
  <Paragraphs>5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u Ling</dc:creator>
  <cp:lastModifiedBy>Du Ling</cp:lastModifiedBy>
  <cp:revision>5</cp:revision>
  <dcterms:created xsi:type="dcterms:W3CDTF">2024-11-28T12:44:47Z</dcterms:created>
  <dcterms:modified xsi:type="dcterms:W3CDTF">2024-12-03T08:58:20Z</dcterms:modified>
</cp:coreProperties>
</file>